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2971800" cy="1828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6" userDrawn="1">
          <p15:clr>
            <a:srgbClr val="A4A3A4"/>
          </p15:clr>
        </p15:guide>
        <p15:guide id="2" pos="9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94" autoAdjust="0"/>
    <p:restoredTop sz="94249" autoAdjust="0"/>
  </p:normalViewPr>
  <p:slideViewPr>
    <p:cSldViewPr snapToGrid="0" showGuides="1">
      <p:cViewPr>
        <p:scale>
          <a:sx n="300" d="100"/>
          <a:sy n="300" d="100"/>
        </p:scale>
        <p:origin x="618" y="-456"/>
      </p:cViewPr>
      <p:guideLst>
        <p:guide orient="horz" pos="576"/>
        <p:guide pos="9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336D28-94FC-4B94-997F-A282C17C16C8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1143000"/>
            <a:ext cx="50165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1833F8-01D4-4B68-87A9-3EAF7CB87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6523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1833F8-01D4-4B68-87A9-3EAF7CB873E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151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1475" y="299297"/>
            <a:ext cx="2228850" cy="636693"/>
          </a:xfrm>
        </p:spPr>
        <p:txBody>
          <a:bodyPr anchor="b"/>
          <a:lstStyle>
            <a:lvl1pPr algn="ctr">
              <a:defRPr sz="146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1475" y="960543"/>
            <a:ext cx="2228850" cy="441537"/>
          </a:xfrm>
        </p:spPr>
        <p:txBody>
          <a:bodyPr/>
          <a:lstStyle>
            <a:lvl1pPr marL="0" indent="0" algn="ctr">
              <a:buNone/>
              <a:defRPr sz="585"/>
            </a:lvl1pPr>
            <a:lvl2pPr marL="111465" indent="0" algn="ctr">
              <a:buNone/>
              <a:defRPr sz="488"/>
            </a:lvl2pPr>
            <a:lvl3pPr marL="222931" indent="0" algn="ctr">
              <a:buNone/>
              <a:defRPr sz="439"/>
            </a:lvl3pPr>
            <a:lvl4pPr marL="334396" indent="0" algn="ctr">
              <a:buNone/>
              <a:defRPr sz="390"/>
            </a:lvl4pPr>
            <a:lvl5pPr marL="445861" indent="0" algn="ctr">
              <a:buNone/>
              <a:defRPr sz="390"/>
            </a:lvl5pPr>
            <a:lvl6pPr marL="557327" indent="0" algn="ctr">
              <a:buNone/>
              <a:defRPr sz="390"/>
            </a:lvl6pPr>
            <a:lvl7pPr marL="668792" indent="0" algn="ctr">
              <a:buNone/>
              <a:defRPr sz="390"/>
            </a:lvl7pPr>
            <a:lvl8pPr marL="780258" indent="0" algn="ctr">
              <a:buNone/>
              <a:defRPr sz="390"/>
            </a:lvl8pPr>
            <a:lvl9pPr marL="891723" indent="0" algn="ctr">
              <a:buNone/>
              <a:defRPr sz="39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474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471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26695" y="97367"/>
            <a:ext cx="640794" cy="15498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4311" y="97367"/>
            <a:ext cx="1885236" cy="154982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1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263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2763" y="455930"/>
            <a:ext cx="2563178" cy="760730"/>
          </a:xfrm>
        </p:spPr>
        <p:txBody>
          <a:bodyPr anchor="b"/>
          <a:lstStyle>
            <a:lvl1pPr>
              <a:defRPr sz="146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2763" y="1223857"/>
            <a:ext cx="2563178" cy="400050"/>
          </a:xfrm>
        </p:spPr>
        <p:txBody>
          <a:bodyPr/>
          <a:lstStyle>
            <a:lvl1pPr marL="0" indent="0">
              <a:buNone/>
              <a:defRPr sz="585">
                <a:solidFill>
                  <a:schemeClr val="tx1">
                    <a:tint val="75000"/>
                  </a:schemeClr>
                </a:solidFill>
              </a:defRPr>
            </a:lvl1pPr>
            <a:lvl2pPr marL="111465" indent="0">
              <a:buNone/>
              <a:defRPr sz="488">
                <a:solidFill>
                  <a:schemeClr val="tx1">
                    <a:tint val="75000"/>
                  </a:schemeClr>
                </a:solidFill>
              </a:defRPr>
            </a:lvl2pPr>
            <a:lvl3pPr marL="222931" indent="0">
              <a:buNone/>
              <a:defRPr sz="439">
                <a:solidFill>
                  <a:schemeClr val="tx1">
                    <a:tint val="75000"/>
                  </a:schemeClr>
                </a:solidFill>
              </a:defRPr>
            </a:lvl3pPr>
            <a:lvl4pPr marL="334396" indent="0">
              <a:buNone/>
              <a:defRPr sz="390">
                <a:solidFill>
                  <a:schemeClr val="tx1">
                    <a:tint val="75000"/>
                  </a:schemeClr>
                </a:solidFill>
              </a:defRPr>
            </a:lvl4pPr>
            <a:lvl5pPr marL="445861" indent="0">
              <a:buNone/>
              <a:defRPr sz="390">
                <a:solidFill>
                  <a:schemeClr val="tx1">
                    <a:tint val="75000"/>
                  </a:schemeClr>
                </a:solidFill>
              </a:defRPr>
            </a:lvl5pPr>
            <a:lvl6pPr marL="557327" indent="0">
              <a:buNone/>
              <a:defRPr sz="390">
                <a:solidFill>
                  <a:schemeClr val="tx1">
                    <a:tint val="75000"/>
                  </a:schemeClr>
                </a:solidFill>
              </a:defRPr>
            </a:lvl6pPr>
            <a:lvl7pPr marL="668792" indent="0">
              <a:buNone/>
              <a:defRPr sz="390">
                <a:solidFill>
                  <a:schemeClr val="tx1">
                    <a:tint val="75000"/>
                  </a:schemeClr>
                </a:solidFill>
              </a:defRPr>
            </a:lvl7pPr>
            <a:lvl8pPr marL="780258" indent="0">
              <a:buNone/>
              <a:defRPr sz="390">
                <a:solidFill>
                  <a:schemeClr val="tx1">
                    <a:tint val="75000"/>
                  </a:schemeClr>
                </a:solidFill>
              </a:defRPr>
            </a:lvl8pPr>
            <a:lvl9pPr marL="891723" indent="0">
              <a:buNone/>
              <a:defRPr sz="3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99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4311" y="486833"/>
            <a:ext cx="1263015" cy="11603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04474" y="486833"/>
            <a:ext cx="1263015" cy="11603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582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4698" y="97367"/>
            <a:ext cx="2563178" cy="35348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4698" y="448310"/>
            <a:ext cx="1257211" cy="219710"/>
          </a:xfrm>
        </p:spPr>
        <p:txBody>
          <a:bodyPr anchor="b"/>
          <a:lstStyle>
            <a:lvl1pPr marL="0" indent="0">
              <a:buNone/>
              <a:defRPr sz="585" b="1"/>
            </a:lvl1pPr>
            <a:lvl2pPr marL="111465" indent="0">
              <a:buNone/>
              <a:defRPr sz="488" b="1"/>
            </a:lvl2pPr>
            <a:lvl3pPr marL="222931" indent="0">
              <a:buNone/>
              <a:defRPr sz="439" b="1"/>
            </a:lvl3pPr>
            <a:lvl4pPr marL="334396" indent="0">
              <a:buNone/>
              <a:defRPr sz="390" b="1"/>
            </a:lvl4pPr>
            <a:lvl5pPr marL="445861" indent="0">
              <a:buNone/>
              <a:defRPr sz="390" b="1"/>
            </a:lvl5pPr>
            <a:lvl6pPr marL="557327" indent="0">
              <a:buNone/>
              <a:defRPr sz="390" b="1"/>
            </a:lvl6pPr>
            <a:lvl7pPr marL="668792" indent="0">
              <a:buNone/>
              <a:defRPr sz="390" b="1"/>
            </a:lvl7pPr>
            <a:lvl8pPr marL="780258" indent="0">
              <a:buNone/>
              <a:defRPr sz="390" b="1"/>
            </a:lvl8pPr>
            <a:lvl9pPr marL="891723" indent="0">
              <a:buNone/>
              <a:defRPr sz="39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4698" y="668020"/>
            <a:ext cx="1257211" cy="9825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04474" y="448310"/>
            <a:ext cx="1263402" cy="219710"/>
          </a:xfrm>
        </p:spPr>
        <p:txBody>
          <a:bodyPr anchor="b"/>
          <a:lstStyle>
            <a:lvl1pPr marL="0" indent="0">
              <a:buNone/>
              <a:defRPr sz="585" b="1"/>
            </a:lvl1pPr>
            <a:lvl2pPr marL="111465" indent="0">
              <a:buNone/>
              <a:defRPr sz="488" b="1"/>
            </a:lvl2pPr>
            <a:lvl3pPr marL="222931" indent="0">
              <a:buNone/>
              <a:defRPr sz="439" b="1"/>
            </a:lvl3pPr>
            <a:lvl4pPr marL="334396" indent="0">
              <a:buNone/>
              <a:defRPr sz="390" b="1"/>
            </a:lvl4pPr>
            <a:lvl5pPr marL="445861" indent="0">
              <a:buNone/>
              <a:defRPr sz="390" b="1"/>
            </a:lvl5pPr>
            <a:lvl6pPr marL="557327" indent="0">
              <a:buNone/>
              <a:defRPr sz="390" b="1"/>
            </a:lvl6pPr>
            <a:lvl7pPr marL="668792" indent="0">
              <a:buNone/>
              <a:defRPr sz="390" b="1"/>
            </a:lvl7pPr>
            <a:lvl8pPr marL="780258" indent="0">
              <a:buNone/>
              <a:defRPr sz="390" b="1"/>
            </a:lvl8pPr>
            <a:lvl9pPr marL="891723" indent="0">
              <a:buNone/>
              <a:defRPr sz="39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04474" y="668020"/>
            <a:ext cx="1263402" cy="9825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082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593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870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4698" y="121920"/>
            <a:ext cx="958483" cy="426720"/>
          </a:xfrm>
        </p:spPr>
        <p:txBody>
          <a:bodyPr anchor="b"/>
          <a:lstStyle>
            <a:lvl1pPr>
              <a:defRPr sz="7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63402" y="263314"/>
            <a:ext cx="1504474" cy="1299633"/>
          </a:xfrm>
        </p:spPr>
        <p:txBody>
          <a:bodyPr/>
          <a:lstStyle>
            <a:lvl1pPr>
              <a:defRPr sz="780"/>
            </a:lvl1pPr>
            <a:lvl2pPr>
              <a:defRPr sz="683"/>
            </a:lvl2pPr>
            <a:lvl3pPr>
              <a:defRPr sz="585"/>
            </a:lvl3pPr>
            <a:lvl4pPr>
              <a:defRPr sz="488"/>
            </a:lvl4pPr>
            <a:lvl5pPr>
              <a:defRPr sz="488"/>
            </a:lvl5pPr>
            <a:lvl6pPr>
              <a:defRPr sz="488"/>
            </a:lvl6pPr>
            <a:lvl7pPr>
              <a:defRPr sz="488"/>
            </a:lvl7pPr>
            <a:lvl8pPr>
              <a:defRPr sz="488"/>
            </a:lvl8pPr>
            <a:lvl9pPr>
              <a:defRPr sz="48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4698" y="548640"/>
            <a:ext cx="958483" cy="1016423"/>
          </a:xfrm>
        </p:spPr>
        <p:txBody>
          <a:bodyPr/>
          <a:lstStyle>
            <a:lvl1pPr marL="0" indent="0">
              <a:buNone/>
              <a:defRPr sz="390"/>
            </a:lvl1pPr>
            <a:lvl2pPr marL="111465" indent="0">
              <a:buNone/>
              <a:defRPr sz="341"/>
            </a:lvl2pPr>
            <a:lvl3pPr marL="222931" indent="0">
              <a:buNone/>
              <a:defRPr sz="293"/>
            </a:lvl3pPr>
            <a:lvl4pPr marL="334396" indent="0">
              <a:buNone/>
              <a:defRPr sz="244"/>
            </a:lvl4pPr>
            <a:lvl5pPr marL="445861" indent="0">
              <a:buNone/>
              <a:defRPr sz="244"/>
            </a:lvl5pPr>
            <a:lvl6pPr marL="557327" indent="0">
              <a:buNone/>
              <a:defRPr sz="244"/>
            </a:lvl6pPr>
            <a:lvl7pPr marL="668792" indent="0">
              <a:buNone/>
              <a:defRPr sz="244"/>
            </a:lvl7pPr>
            <a:lvl8pPr marL="780258" indent="0">
              <a:buNone/>
              <a:defRPr sz="244"/>
            </a:lvl8pPr>
            <a:lvl9pPr marL="891723" indent="0">
              <a:buNone/>
              <a:defRPr sz="2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559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4698" y="121920"/>
            <a:ext cx="958483" cy="426720"/>
          </a:xfrm>
        </p:spPr>
        <p:txBody>
          <a:bodyPr anchor="b"/>
          <a:lstStyle>
            <a:lvl1pPr>
              <a:defRPr sz="7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63402" y="263314"/>
            <a:ext cx="1504474" cy="1299633"/>
          </a:xfrm>
        </p:spPr>
        <p:txBody>
          <a:bodyPr anchor="t"/>
          <a:lstStyle>
            <a:lvl1pPr marL="0" indent="0">
              <a:buNone/>
              <a:defRPr sz="780"/>
            </a:lvl1pPr>
            <a:lvl2pPr marL="111465" indent="0">
              <a:buNone/>
              <a:defRPr sz="683"/>
            </a:lvl2pPr>
            <a:lvl3pPr marL="222931" indent="0">
              <a:buNone/>
              <a:defRPr sz="585"/>
            </a:lvl3pPr>
            <a:lvl4pPr marL="334396" indent="0">
              <a:buNone/>
              <a:defRPr sz="488"/>
            </a:lvl4pPr>
            <a:lvl5pPr marL="445861" indent="0">
              <a:buNone/>
              <a:defRPr sz="488"/>
            </a:lvl5pPr>
            <a:lvl6pPr marL="557327" indent="0">
              <a:buNone/>
              <a:defRPr sz="488"/>
            </a:lvl6pPr>
            <a:lvl7pPr marL="668792" indent="0">
              <a:buNone/>
              <a:defRPr sz="488"/>
            </a:lvl7pPr>
            <a:lvl8pPr marL="780258" indent="0">
              <a:buNone/>
              <a:defRPr sz="488"/>
            </a:lvl8pPr>
            <a:lvl9pPr marL="891723" indent="0">
              <a:buNone/>
              <a:defRPr sz="48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4698" y="548640"/>
            <a:ext cx="958483" cy="1016423"/>
          </a:xfrm>
        </p:spPr>
        <p:txBody>
          <a:bodyPr/>
          <a:lstStyle>
            <a:lvl1pPr marL="0" indent="0">
              <a:buNone/>
              <a:defRPr sz="390"/>
            </a:lvl1pPr>
            <a:lvl2pPr marL="111465" indent="0">
              <a:buNone/>
              <a:defRPr sz="341"/>
            </a:lvl2pPr>
            <a:lvl3pPr marL="222931" indent="0">
              <a:buNone/>
              <a:defRPr sz="293"/>
            </a:lvl3pPr>
            <a:lvl4pPr marL="334396" indent="0">
              <a:buNone/>
              <a:defRPr sz="244"/>
            </a:lvl4pPr>
            <a:lvl5pPr marL="445861" indent="0">
              <a:buNone/>
              <a:defRPr sz="244"/>
            </a:lvl5pPr>
            <a:lvl6pPr marL="557327" indent="0">
              <a:buNone/>
              <a:defRPr sz="244"/>
            </a:lvl6pPr>
            <a:lvl7pPr marL="668792" indent="0">
              <a:buNone/>
              <a:defRPr sz="244"/>
            </a:lvl7pPr>
            <a:lvl8pPr marL="780258" indent="0">
              <a:buNone/>
              <a:defRPr sz="244"/>
            </a:lvl8pPr>
            <a:lvl9pPr marL="891723" indent="0">
              <a:buNone/>
              <a:defRPr sz="2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863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4311" y="97367"/>
            <a:ext cx="2563178" cy="3534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4311" y="486833"/>
            <a:ext cx="2563178" cy="11603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4311" y="1695027"/>
            <a:ext cx="668655" cy="973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11BD9E-349B-416C-A760-63D7CD305246}" type="datetimeFigureOut">
              <a:rPr lang="en-US" smtClean="0"/>
              <a:t>2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84409" y="1695027"/>
            <a:ext cx="1002983" cy="973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98834" y="1695027"/>
            <a:ext cx="668655" cy="973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FFF52-66F9-42AE-8E7D-EDA01B164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89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22931" rtl="0" eaLnBrk="1" latinLnBrk="0" hangingPunct="1">
        <a:lnSpc>
          <a:spcPct val="90000"/>
        </a:lnSpc>
        <a:spcBef>
          <a:spcPct val="0"/>
        </a:spcBef>
        <a:buNone/>
        <a:defRPr sz="10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5733" indent="-55733" algn="l" defTabSz="222931" rtl="0" eaLnBrk="1" latinLnBrk="0" hangingPunct="1">
        <a:lnSpc>
          <a:spcPct val="90000"/>
        </a:lnSpc>
        <a:spcBef>
          <a:spcPts val="244"/>
        </a:spcBef>
        <a:buFont typeface="Arial" panose="020B0604020202020204" pitchFamily="34" charset="0"/>
        <a:buChar char="•"/>
        <a:defRPr sz="683" kern="1200">
          <a:solidFill>
            <a:schemeClr val="tx1"/>
          </a:solidFill>
          <a:latin typeface="+mn-lt"/>
          <a:ea typeface="+mn-ea"/>
          <a:cs typeface="+mn-cs"/>
        </a:defRPr>
      </a:lvl1pPr>
      <a:lvl2pPr marL="167198" indent="-55733" algn="l" defTabSz="222931" rtl="0" eaLnBrk="1" latinLnBrk="0" hangingPunct="1">
        <a:lnSpc>
          <a:spcPct val="90000"/>
        </a:lnSpc>
        <a:spcBef>
          <a:spcPts val="122"/>
        </a:spcBef>
        <a:buFont typeface="Arial" panose="020B0604020202020204" pitchFamily="34" charset="0"/>
        <a:buChar char="•"/>
        <a:defRPr sz="585" kern="1200">
          <a:solidFill>
            <a:schemeClr val="tx1"/>
          </a:solidFill>
          <a:latin typeface="+mn-lt"/>
          <a:ea typeface="+mn-ea"/>
          <a:cs typeface="+mn-cs"/>
        </a:defRPr>
      </a:lvl2pPr>
      <a:lvl3pPr marL="278663" indent="-55733" algn="l" defTabSz="222931" rtl="0" eaLnBrk="1" latinLnBrk="0" hangingPunct="1">
        <a:lnSpc>
          <a:spcPct val="90000"/>
        </a:lnSpc>
        <a:spcBef>
          <a:spcPts val="122"/>
        </a:spcBef>
        <a:buFont typeface="Arial" panose="020B0604020202020204" pitchFamily="34" charset="0"/>
        <a:buChar char="•"/>
        <a:defRPr sz="488" kern="1200">
          <a:solidFill>
            <a:schemeClr val="tx1"/>
          </a:solidFill>
          <a:latin typeface="+mn-lt"/>
          <a:ea typeface="+mn-ea"/>
          <a:cs typeface="+mn-cs"/>
        </a:defRPr>
      </a:lvl3pPr>
      <a:lvl4pPr marL="390129" indent="-55733" algn="l" defTabSz="222931" rtl="0" eaLnBrk="1" latinLnBrk="0" hangingPunct="1">
        <a:lnSpc>
          <a:spcPct val="90000"/>
        </a:lnSpc>
        <a:spcBef>
          <a:spcPts val="122"/>
        </a:spcBef>
        <a:buFont typeface="Arial" panose="020B0604020202020204" pitchFamily="34" charset="0"/>
        <a:buChar char="•"/>
        <a:defRPr sz="439" kern="1200">
          <a:solidFill>
            <a:schemeClr val="tx1"/>
          </a:solidFill>
          <a:latin typeface="+mn-lt"/>
          <a:ea typeface="+mn-ea"/>
          <a:cs typeface="+mn-cs"/>
        </a:defRPr>
      </a:lvl4pPr>
      <a:lvl5pPr marL="501594" indent="-55733" algn="l" defTabSz="222931" rtl="0" eaLnBrk="1" latinLnBrk="0" hangingPunct="1">
        <a:lnSpc>
          <a:spcPct val="90000"/>
        </a:lnSpc>
        <a:spcBef>
          <a:spcPts val="122"/>
        </a:spcBef>
        <a:buFont typeface="Arial" panose="020B0604020202020204" pitchFamily="34" charset="0"/>
        <a:buChar char="•"/>
        <a:defRPr sz="439" kern="1200">
          <a:solidFill>
            <a:schemeClr val="tx1"/>
          </a:solidFill>
          <a:latin typeface="+mn-lt"/>
          <a:ea typeface="+mn-ea"/>
          <a:cs typeface="+mn-cs"/>
        </a:defRPr>
      </a:lvl5pPr>
      <a:lvl6pPr marL="613059" indent="-55733" algn="l" defTabSz="222931" rtl="0" eaLnBrk="1" latinLnBrk="0" hangingPunct="1">
        <a:lnSpc>
          <a:spcPct val="90000"/>
        </a:lnSpc>
        <a:spcBef>
          <a:spcPts val="122"/>
        </a:spcBef>
        <a:buFont typeface="Arial" panose="020B0604020202020204" pitchFamily="34" charset="0"/>
        <a:buChar char="•"/>
        <a:defRPr sz="439" kern="1200">
          <a:solidFill>
            <a:schemeClr val="tx1"/>
          </a:solidFill>
          <a:latin typeface="+mn-lt"/>
          <a:ea typeface="+mn-ea"/>
          <a:cs typeface="+mn-cs"/>
        </a:defRPr>
      </a:lvl6pPr>
      <a:lvl7pPr marL="724525" indent="-55733" algn="l" defTabSz="222931" rtl="0" eaLnBrk="1" latinLnBrk="0" hangingPunct="1">
        <a:lnSpc>
          <a:spcPct val="90000"/>
        </a:lnSpc>
        <a:spcBef>
          <a:spcPts val="122"/>
        </a:spcBef>
        <a:buFont typeface="Arial" panose="020B0604020202020204" pitchFamily="34" charset="0"/>
        <a:buChar char="•"/>
        <a:defRPr sz="439" kern="1200">
          <a:solidFill>
            <a:schemeClr val="tx1"/>
          </a:solidFill>
          <a:latin typeface="+mn-lt"/>
          <a:ea typeface="+mn-ea"/>
          <a:cs typeface="+mn-cs"/>
        </a:defRPr>
      </a:lvl7pPr>
      <a:lvl8pPr marL="835990" indent="-55733" algn="l" defTabSz="222931" rtl="0" eaLnBrk="1" latinLnBrk="0" hangingPunct="1">
        <a:lnSpc>
          <a:spcPct val="90000"/>
        </a:lnSpc>
        <a:spcBef>
          <a:spcPts val="122"/>
        </a:spcBef>
        <a:buFont typeface="Arial" panose="020B0604020202020204" pitchFamily="34" charset="0"/>
        <a:buChar char="•"/>
        <a:defRPr sz="439" kern="1200">
          <a:solidFill>
            <a:schemeClr val="tx1"/>
          </a:solidFill>
          <a:latin typeface="+mn-lt"/>
          <a:ea typeface="+mn-ea"/>
          <a:cs typeface="+mn-cs"/>
        </a:defRPr>
      </a:lvl8pPr>
      <a:lvl9pPr marL="947456" indent="-55733" algn="l" defTabSz="222931" rtl="0" eaLnBrk="1" latinLnBrk="0" hangingPunct="1">
        <a:lnSpc>
          <a:spcPct val="90000"/>
        </a:lnSpc>
        <a:spcBef>
          <a:spcPts val="122"/>
        </a:spcBef>
        <a:buFont typeface="Arial" panose="020B0604020202020204" pitchFamily="34" charset="0"/>
        <a:buChar char="•"/>
        <a:defRPr sz="4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22931" rtl="0" eaLnBrk="1" latinLnBrk="0" hangingPunct="1">
        <a:defRPr sz="439" kern="1200">
          <a:solidFill>
            <a:schemeClr val="tx1"/>
          </a:solidFill>
          <a:latin typeface="+mn-lt"/>
          <a:ea typeface="+mn-ea"/>
          <a:cs typeface="+mn-cs"/>
        </a:defRPr>
      </a:lvl1pPr>
      <a:lvl2pPr marL="111465" algn="l" defTabSz="222931" rtl="0" eaLnBrk="1" latinLnBrk="0" hangingPunct="1">
        <a:defRPr sz="439" kern="1200">
          <a:solidFill>
            <a:schemeClr val="tx1"/>
          </a:solidFill>
          <a:latin typeface="+mn-lt"/>
          <a:ea typeface="+mn-ea"/>
          <a:cs typeface="+mn-cs"/>
        </a:defRPr>
      </a:lvl2pPr>
      <a:lvl3pPr marL="222931" algn="l" defTabSz="222931" rtl="0" eaLnBrk="1" latinLnBrk="0" hangingPunct="1">
        <a:defRPr sz="439" kern="1200">
          <a:solidFill>
            <a:schemeClr val="tx1"/>
          </a:solidFill>
          <a:latin typeface="+mn-lt"/>
          <a:ea typeface="+mn-ea"/>
          <a:cs typeface="+mn-cs"/>
        </a:defRPr>
      </a:lvl3pPr>
      <a:lvl4pPr marL="334396" algn="l" defTabSz="222931" rtl="0" eaLnBrk="1" latinLnBrk="0" hangingPunct="1">
        <a:defRPr sz="439" kern="1200">
          <a:solidFill>
            <a:schemeClr val="tx1"/>
          </a:solidFill>
          <a:latin typeface="+mn-lt"/>
          <a:ea typeface="+mn-ea"/>
          <a:cs typeface="+mn-cs"/>
        </a:defRPr>
      </a:lvl4pPr>
      <a:lvl5pPr marL="445861" algn="l" defTabSz="222931" rtl="0" eaLnBrk="1" latinLnBrk="0" hangingPunct="1">
        <a:defRPr sz="439" kern="1200">
          <a:solidFill>
            <a:schemeClr val="tx1"/>
          </a:solidFill>
          <a:latin typeface="+mn-lt"/>
          <a:ea typeface="+mn-ea"/>
          <a:cs typeface="+mn-cs"/>
        </a:defRPr>
      </a:lvl5pPr>
      <a:lvl6pPr marL="557327" algn="l" defTabSz="222931" rtl="0" eaLnBrk="1" latinLnBrk="0" hangingPunct="1">
        <a:defRPr sz="439" kern="1200">
          <a:solidFill>
            <a:schemeClr val="tx1"/>
          </a:solidFill>
          <a:latin typeface="+mn-lt"/>
          <a:ea typeface="+mn-ea"/>
          <a:cs typeface="+mn-cs"/>
        </a:defRPr>
      </a:lvl6pPr>
      <a:lvl7pPr marL="668792" algn="l" defTabSz="222931" rtl="0" eaLnBrk="1" latinLnBrk="0" hangingPunct="1">
        <a:defRPr sz="439" kern="1200">
          <a:solidFill>
            <a:schemeClr val="tx1"/>
          </a:solidFill>
          <a:latin typeface="+mn-lt"/>
          <a:ea typeface="+mn-ea"/>
          <a:cs typeface="+mn-cs"/>
        </a:defRPr>
      </a:lvl7pPr>
      <a:lvl8pPr marL="780258" algn="l" defTabSz="222931" rtl="0" eaLnBrk="1" latinLnBrk="0" hangingPunct="1">
        <a:defRPr sz="439" kern="1200">
          <a:solidFill>
            <a:schemeClr val="tx1"/>
          </a:solidFill>
          <a:latin typeface="+mn-lt"/>
          <a:ea typeface="+mn-ea"/>
          <a:cs typeface="+mn-cs"/>
        </a:defRPr>
      </a:lvl8pPr>
      <a:lvl9pPr marL="891723" algn="l" defTabSz="222931" rtl="0" eaLnBrk="1" latinLnBrk="0" hangingPunct="1">
        <a:defRPr sz="4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3" name="Group 122">
            <a:extLst>
              <a:ext uri="{FF2B5EF4-FFF2-40B4-BE49-F238E27FC236}">
                <a16:creationId xmlns:a16="http://schemas.microsoft.com/office/drawing/2014/main" id="{A7F32416-DC71-4FC9-9927-046394BCAEE2}"/>
              </a:ext>
            </a:extLst>
          </p:cNvPr>
          <p:cNvGrpSpPr/>
          <p:nvPr/>
        </p:nvGrpSpPr>
        <p:grpSpPr>
          <a:xfrm>
            <a:off x="106460" y="169068"/>
            <a:ext cx="1678381" cy="1490664"/>
            <a:chOff x="-122631" y="214311"/>
            <a:chExt cx="1678381" cy="1490664"/>
          </a:xfrm>
        </p:grpSpPr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E98DF624-561A-428B-BAB7-F87E4EFF59E5}"/>
                </a:ext>
              </a:extLst>
            </p:cNvPr>
            <p:cNvGrpSpPr/>
            <p:nvPr/>
          </p:nvGrpSpPr>
          <p:grpSpPr>
            <a:xfrm>
              <a:off x="-122631" y="214311"/>
              <a:ext cx="1678381" cy="1490664"/>
              <a:chOff x="1829994" y="576261"/>
              <a:chExt cx="1132721" cy="1152524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983184C3-2F18-4A6A-BDFB-672E986B97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940" t="26971" r="37902" b="30122"/>
              <a:stretch/>
            </p:blipFill>
            <p:spPr>
              <a:xfrm rot="10800000">
                <a:off x="1971675" y="576261"/>
                <a:ext cx="852488" cy="1152524"/>
              </a:xfrm>
              <a:prstGeom prst="rect">
                <a:avLst/>
              </a:prstGeom>
            </p:spPr>
          </p:pic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65855295-A906-40E6-8655-8F0831CF22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64500" y="771931"/>
                <a:ext cx="12027" cy="70087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D76E469D-D93F-480A-AF26-CB52E01571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49803" y="771931"/>
                <a:ext cx="6901" cy="70087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A8BDAACF-2BE9-4AF0-88E2-3148A7D7393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276527" y="1472803"/>
                <a:ext cx="280178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B9DE3F3B-98D0-424D-803F-EFE99F4CF59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269625" y="771931"/>
                <a:ext cx="280178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9CC204F9-28DA-4CD5-BED9-46A6C3380579}"/>
                  </a:ext>
                </a:extLst>
              </p:cNvPr>
              <p:cNvSpPr txBox="1"/>
              <p:nvPr/>
            </p:nvSpPr>
            <p:spPr>
              <a:xfrm>
                <a:off x="2234842" y="1057855"/>
                <a:ext cx="392881" cy="142777"/>
              </a:xfrm>
              <a:prstGeom prst="rect">
                <a:avLst/>
              </a:prstGeom>
              <a:noFill/>
              <a:ln w="3175"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Columella</a:t>
                </a:r>
              </a:p>
            </p:txBody>
          </p: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D053E5B5-1804-41E6-A465-4D736DA0DF0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119313" y="1381125"/>
                <a:ext cx="126258" cy="1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3E0E4FA3-265E-4E1F-8F99-BADEDB46729D}"/>
                  </a:ext>
                </a:extLst>
              </p:cNvPr>
              <p:cNvSpPr txBox="1"/>
              <p:nvPr/>
            </p:nvSpPr>
            <p:spPr>
              <a:xfrm>
                <a:off x="2055019" y="1461383"/>
                <a:ext cx="713184" cy="142777"/>
              </a:xfrm>
              <a:prstGeom prst="rect">
                <a:avLst/>
              </a:prstGeom>
              <a:noFill/>
              <a:ln w="3175"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Blossom-end </a:t>
                </a:r>
              </a:p>
            </p:txBody>
          </p: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4AF3A7D2-E43E-4F75-8B78-6B35EEFC3A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45571" y="1381125"/>
                <a:ext cx="30956" cy="91678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A6600820-0916-4148-816F-1539633DEC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56704" y="1395413"/>
                <a:ext cx="37655" cy="7739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267CFC0B-3295-4224-9B50-1D12D9872DE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94359" y="1395412"/>
                <a:ext cx="126258" cy="1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>
                <a:extLst>
                  <a:ext uri="{FF2B5EF4-FFF2-40B4-BE49-F238E27FC236}">
                    <a16:creationId xmlns:a16="http://schemas.microsoft.com/office/drawing/2014/main" id="{9CBB0E3F-C659-4F44-B36B-EC0362CD979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133956" y="852228"/>
                <a:ext cx="130652" cy="79807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770EB4C9-4944-4079-AFBC-B0CC27624F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033590" y="932035"/>
                <a:ext cx="101677" cy="451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9C8196A3-F210-4BA5-A1EB-21401B76384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646337" y="914400"/>
                <a:ext cx="84663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10C3B8B4-CB26-4EEB-94EB-9A258DCD36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3253" y="837902"/>
                <a:ext cx="93084" cy="76498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02924FCE-891C-4CAA-8BC2-35901789E1FF}"/>
                  </a:ext>
                </a:extLst>
              </p:cNvPr>
              <p:cNvSpPr txBox="1"/>
              <p:nvPr/>
            </p:nvSpPr>
            <p:spPr>
              <a:xfrm>
                <a:off x="1829994" y="716233"/>
                <a:ext cx="713184" cy="190369"/>
              </a:xfrm>
              <a:prstGeom prst="rect">
                <a:avLst/>
              </a:prstGeom>
              <a:noFill/>
              <a:ln w="3175"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/>
                  <a:t>Stem</a:t>
                </a:r>
              </a:p>
              <a:p>
                <a:pPr algn="ctr"/>
                <a:r>
                  <a:rPr lang="en-US" sz="500" dirty="0"/>
                  <a:t>end 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B3883A34-7992-464C-999E-DC6A44B0879A}"/>
                  </a:ext>
                </a:extLst>
              </p:cNvPr>
              <p:cNvSpPr txBox="1"/>
              <p:nvPr/>
            </p:nvSpPr>
            <p:spPr>
              <a:xfrm>
                <a:off x="2249531" y="709091"/>
                <a:ext cx="713184" cy="190369"/>
              </a:xfrm>
              <a:prstGeom prst="rect">
                <a:avLst/>
              </a:prstGeom>
              <a:noFill/>
              <a:ln w="3175"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/>
                  <a:t>Stem</a:t>
                </a:r>
              </a:p>
              <a:p>
                <a:pPr algn="ctr"/>
                <a:r>
                  <a:rPr lang="en-US" sz="500" dirty="0"/>
                  <a:t>end 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8FA5917F-B381-4B96-AC21-48DA6522104A}"/>
                  </a:ext>
                </a:extLst>
              </p:cNvPr>
              <p:cNvSpPr txBox="1"/>
              <p:nvPr/>
            </p:nvSpPr>
            <p:spPr>
              <a:xfrm rot="4665459">
                <a:off x="1749023" y="1112029"/>
                <a:ext cx="713184" cy="124629"/>
              </a:xfrm>
              <a:prstGeom prst="rect">
                <a:avLst/>
              </a:prstGeom>
              <a:noFill/>
              <a:ln w="3175"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Middle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563E55F3-1BBE-4D5C-8C86-5CF0D1B172DD}"/>
                  </a:ext>
                </a:extLst>
              </p:cNvPr>
              <p:cNvSpPr txBox="1"/>
              <p:nvPr/>
            </p:nvSpPr>
            <p:spPr>
              <a:xfrm rot="16425516">
                <a:off x="2339792" y="1107671"/>
                <a:ext cx="713184" cy="124629"/>
              </a:xfrm>
              <a:prstGeom prst="rect">
                <a:avLst/>
              </a:prstGeom>
              <a:noFill/>
              <a:ln w="3175"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Middle</a:t>
                </a:r>
              </a:p>
            </p:txBody>
          </p: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F1D6D113-210C-4FA9-B792-9C46E388B9B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264499" y="680024"/>
                <a:ext cx="68695" cy="91907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>
                <a:extLst>
                  <a:ext uri="{FF2B5EF4-FFF2-40B4-BE49-F238E27FC236}">
                    <a16:creationId xmlns:a16="http://schemas.microsoft.com/office/drawing/2014/main" id="{7C1728F2-3B0E-41D3-BE40-A12B76EF83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76504" y="677455"/>
                <a:ext cx="75717" cy="94476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id="{C3953F27-0550-4848-B211-54909B8F3CA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602486" y="1053642"/>
                <a:ext cx="71770" cy="34177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>
                <a:extLst>
                  <a:ext uri="{FF2B5EF4-FFF2-40B4-BE49-F238E27FC236}">
                    <a16:creationId xmlns:a16="http://schemas.microsoft.com/office/drawing/2014/main" id="{8892A0A9-6B59-4DF5-9663-CBBFB2EF9D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6208" y="914400"/>
                <a:ext cx="30167" cy="139241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>
                <a:extLst>
                  <a:ext uri="{FF2B5EF4-FFF2-40B4-BE49-F238E27FC236}">
                    <a16:creationId xmlns:a16="http://schemas.microsoft.com/office/drawing/2014/main" id="{F8DD27A3-6ED4-4118-BEE9-F745D093D5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19312" y="1045549"/>
                <a:ext cx="118746" cy="337956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02BC5B3F-0814-4FFA-9C44-FEB8F49E120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121416" y="932486"/>
                <a:ext cx="14474" cy="11221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150238B7-D316-4DC8-9F59-DAAF554F493F}"/>
                </a:ext>
              </a:extLst>
            </p:cNvPr>
            <p:cNvSpPr txBox="1"/>
            <p:nvPr/>
          </p:nvSpPr>
          <p:spPr>
            <a:xfrm>
              <a:off x="98318" y="225734"/>
              <a:ext cx="142072" cy="2062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36576" rtlCol="0">
              <a:spAutoFit/>
            </a:bodyPr>
            <a:lstStyle/>
            <a:p>
              <a:pPr algn="ctr"/>
              <a:r>
                <a:rPr lang="en-US" sz="800" dirty="0"/>
                <a:t>a</a:t>
              </a:r>
            </a:p>
          </p:txBody>
        </p:sp>
      </p:grpSp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AE57A09C-EFBF-4E08-A084-2784C7C1A4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1385336"/>
              </p:ext>
            </p:extLst>
          </p:nvPr>
        </p:nvGraphicFramePr>
        <p:xfrm>
          <a:off x="1595058" y="169069"/>
          <a:ext cx="938499" cy="14935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615814">
                  <a:extLst>
                    <a:ext uri="{9D8B030D-6E8A-4147-A177-3AD203B41FA5}">
                      <a16:colId xmlns:a16="http://schemas.microsoft.com/office/drawing/2014/main" val="1005279614"/>
                    </a:ext>
                  </a:extLst>
                </a:gridCol>
                <a:gridCol w="322685">
                  <a:extLst>
                    <a:ext uri="{9D8B030D-6E8A-4147-A177-3AD203B41FA5}">
                      <a16:colId xmlns:a16="http://schemas.microsoft.com/office/drawing/2014/main" val="3809390854"/>
                    </a:ext>
                  </a:extLst>
                </a:gridCol>
              </a:tblGrid>
              <a:tr h="268518"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 dirty="0"/>
                        <a:t>Examples of visual </a:t>
                      </a:r>
                      <a:br>
                        <a:rPr lang="en-US" sz="600" dirty="0"/>
                      </a:br>
                      <a:r>
                        <a:rPr lang="en-US" sz="600" dirty="0"/>
                        <a:t>symptom ratings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r>
                        <a:rPr lang="en-US" sz="500" dirty="0"/>
                        <a:t>Exampl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6657283"/>
                  </a:ext>
                </a:extLst>
              </a:tr>
              <a:tr h="231879">
                <a:tc>
                  <a:txBody>
                    <a:bodyPr/>
                    <a:lstStyle/>
                    <a:p>
                      <a:r>
                        <a:rPr lang="en-US" sz="1000" dirty="0"/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2209547"/>
                  </a:ext>
                </a:extLst>
              </a:tr>
              <a:tr h="231879"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0231394"/>
                  </a:ext>
                </a:extLst>
              </a:tr>
              <a:tr h="231879">
                <a:tc>
                  <a:txBody>
                    <a:bodyPr/>
                    <a:lstStyle/>
                    <a:p>
                      <a:r>
                        <a:rPr lang="en-US" sz="1000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3346183"/>
                  </a:ext>
                </a:extLst>
              </a:tr>
              <a:tr h="231879">
                <a:tc>
                  <a:txBody>
                    <a:bodyPr/>
                    <a:lstStyle/>
                    <a:p>
                      <a:r>
                        <a:rPr lang="en-US" sz="1000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522405"/>
                  </a:ext>
                </a:extLst>
              </a:tr>
              <a:tr h="231879">
                <a:tc>
                  <a:txBody>
                    <a:bodyPr/>
                    <a:lstStyle/>
                    <a:p>
                      <a:r>
                        <a:rPr lang="en-US" sz="1000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9449129"/>
                  </a:ext>
                </a:extLst>
              </a:tr>
            </a:tbl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04DC7E04-D100-4FEB-8A86-F3A347D502DB}"/>
              </a:ext>
            </a:extLst>
          </p:cNvPr>
          <p:cNvSpPr txBox="1"/>
          <p:nvPr/>
        </p:nvSpPr>
        <p:spPr>
          <a:xfrm>
            <a:off x="1614682" y="194273"/>
            <a:ext cx="142072" cy="206210"/>
          </a:xfrm>
          <a:prstGeom prst="rect">
            <a:avLst/>
          </a:prstGeom>
          <a:solidFill>
            <a:schemeClr val="bg1"/>
          </a:solidFill>
        </p:spPr>
        <p:txBody>
          <a:bodyPr wrap="square" tIns="36576" rtlCol="0">
            <a:spAutoFit/>
          </a:bodyPr>
          <a:lstStyle/>
          <a:p>
            <a:pPr algn="ctr"/>
            <a:r>
              <a:rPr lang="en-US" sz="800" dirty="0"/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14B4B41-1367-40D5-84CC-91509FE4767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08" t="46127" r="39566" b="43081"/>
          <a:stretch/>
        </p:blipFill>
        <p:spPr>
          <a:xfrm>
            <a:off x="2240510" y="447365"/>
            <a:ext cx="258297" cy="22868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E8EC6BCF-D867-4D06-8FA8-DBFDBE136FA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243" t="18017" r="49014" b="71234"/>
          <a:stretch/>
        </p:blipFill>
        <p:spPr>
          <a:xfrm>
            <a:off x="2240510" y="931637"/>
            <a:ext cx="258297" cy="239057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26A10425-0856-4E9A-AA8B-14B4F94BB56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853" t="17663" r="20762" b="71955"/>
          <a:stretch/>
        </p:blipFill>
        <p:spPr>
          <a:xfrm>
            <a:off x="2243701" y="1421026"/>
            <a:ext cx="255106" cy="239056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59A1633A-F7A3-43E2-B58C-1CDF0FDC486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51" t="30796" r="68464" b="58822"/>
          <a:stretch/>
        </p:blipFill>
        <p:spPr>
          <a:xfrm>
            <a:off x="2243701" y="1177083"/>
            <a:ext cx="255106" cy="239056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B7E12C75-6A52-424F-A669-C84180D1833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39" t="32726" r="58476" b="56892"/>
          <a:stretch/>
        </p:blipFill>
        <p:spPr>
          <a:xfrm rot="10800000">
            <a:off x="2243701" y="683811"/>
            <a:ext cx="255106" cy="2390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5677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7</TotalTime>
  <Words>22</Words>
  <Application>Microsoft Office PowerPoint</Application>
  <PresentationFormat>Custom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holas Frederick Reitz</dc:creator>
  <cp:lastModifiedBy>Nicholas Frederick Reitz</cp:lastModifiedBy>
  <cp:revision>9</cp:revision>
  <dcterms:created xsi:type="dcterms:W3CDTF">2021-02-02T01:49:21Z</dcterms:created>
  <dcterms:modified xsi:type="dcterms:W3CDTF">2021-02-02T08:03:32Z</dcterms:modified>
</cp:coreProperties>
</file>